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26E06-0393-4322-93F1-5EB5AEE563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B9E20-966A-4939-90AE-5B102FA916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D7590-4598-424C-899A-B25E78A8B1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09A19-31CF-44A1-84FF-3B3A7D86EE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32970-12B8-413A-B79B-D9B1DD6D80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B52E1-4BBF-4F49-8848-64380CA862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78C73-2EF6-4FCD-A929-2E04F2E3B2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B67C8-F176-4A5E-A9E7-7F28602586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4ED7F-1F9B-4287-B3B4-A35342AEB1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6213CB-7722-4E58-9C9F-C196D1C95F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896D5-1D23-4737-8917-FC376E703F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C365F-73F7-42AF-BB32-A9A0F3194A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6DAD88-70B4-4ABE-8B8E-393BF431E21B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943600" y="2133720"/>
            <a:ext cx="304920" cy="30456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5943600" y="1752480"/>
            <a:ext cx="304920" cy="304920"/>
          </a:xfrm>
          <a:prstGeom prst="rect">
            <a:avLst/>
          </a:prstGeom>
          <a:solidFill>
            <a:srgbClr val="9933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193440" y="1771560"/>
            <a:ext cx="98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30% Epibol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184080" y="2168640"/>
            <a:ext cx="98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50% Epibol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5884920" y="5518080"/>
            <a:ext cx="304920" cy="50796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6948360" y="5456160"/>
            <a:ext cx="304920" cy="56988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8008920" y="4255920"/>
            <a:ext cx="304920" cy="177012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7253280" y="5772240"/>
            <a:ext cx="301680" cy="25380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8313840" y="5881680"/>
            <a:ext cx="304560" cy="14436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5513400" y="6026040"/>
            <a:ext cx="144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513400" y="5618160"/>
            <a:ext cx="14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513400" y="5210280"/>
            <a:ext cx="14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5513400" y="4805280"/>
            <a:ext cx="144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5513400" y="4397400"/>
            <a:ext cx="14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5513400" y="3989520"/>
            <a:ext cx="14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5527800" y="602604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6721560" y="6026040"/>
            <a:ext cx="144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7781760" y="6026040"/>
            <a:ext cx="1800" cy="14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394960" y="5999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5367600" y="55911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367600" y="5183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367600" y="4778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5367600" y="43704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341320" y="39625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6093000" y="6067440"/>
            <a:ext cx="203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U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7153920" y="606744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A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8228160" y="6067440"/>
            <a:ext cx="28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I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 rot="16230000">
            <a:off x="-163800" y="4810680"/>
            <a:ext cx="182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otochord Defects (%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543040" y="5450040"/>
            <a:ext cx="289080" cy="51912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1824120" y="5923080"/>
            <a:ext cx="287280" cy="4608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832120" y="5773680"/>
            <a:ext cx="287280" cy="19548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3838680" y="5954760"/>
            <a:ext cx="285480" cy="1440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1168560" y="596916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1168560" y="55548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1168560" y="51404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1168560" y="47228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1168560" y="43070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1168560" y="389268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1184400" y="5969160"/>
            <a:ext cx="144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2327400" y="5969160"/>
            <a:ext cx="144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3335400" y="5969160"/>
            <a:ext cx="1440" cy="15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1118520" y="5945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1092240" y="5530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1092240" y="51148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1092240" y="4697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1092240" y="42829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1066320" y="38685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1795320" y="6013440"/>
            <a:ext cx="203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U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2697840" y="601344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A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3795840" y="6013440"/>
            <a:ext cx="28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I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4191840" y="4799160"/>
            <a:ext cx="164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n Fold Defects (%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1373040" y="3862440"/>
            <a:ext cx="0" cy="213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1670040" y="2055960"/>
            <a:ext cx="206280" cy="99360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2387520" y="2158920"/>
            <a:ext cx="206280" cy="89064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105000" y="1289160"/>
            <a:ext cx="206640" cy="1760400"/>
          </a:xfrm>
          <a:prstGeom prst="rect">
            <a:avLst/>
          </a:prstGeom>
          <a:solidFill>
            <a:srgbClr val="9933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1876320" y="1125360"/>
            <a:ext cx="204840" cy="192420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2593800" y="1185840"/>
            <a:ext cx="206640" cy="186372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311640" y="979560"/>
            <a:ext cx="203040" cy="2070000"/>
          </a:xfrm>
          <a:prstGeom prst="rect">
            <a:avLst/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347840" y="305928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347840" y="264492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1347840" y="22320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1347840" y="18162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1347840" y="140508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1347840" y="98892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 flipV="1">
            <a:off x="1363680" y="3059280"/>
            <a:ext cx="1440" cy="17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2235240" y="3059280"/>
            <a:ext cx="1440" cy="17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2952720" y="3059280"/>
            <a:ext cx="1440" cy="17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3666960" y="3059280"/>
            <a:ext cx="1800" cy="17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 rot="16200000">
            <a:off x="490320" y="1869120"/>
            <a:ext cx="875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rvival (%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1289880" y="3029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1260720" y="2614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1260720" y="22017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1260720" y="17859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1260720" y="13748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1229760" y="95868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1771560" y="3106800"/>
            <a:ext cx="203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U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2437200" y="310680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A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3137040" y="3106800"/>
            <a:ext cx="28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IK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1523880" y="990720"/>
            <a:ext cx="0" cy="2057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1523880" y="3048120"/>
            <a:ext cx="228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 rot="16288800">
            <a:off x="3712320" y="55958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14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rot="16288800">
            <a:off x="3141000" y="66132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14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 rot="16288800">
            <a:off x="3461400" y="56080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6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 rot="16288800">
            <a:off x="8198640" y="553968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14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 rot="16288800">
            <a:off x="7938360" y="39315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6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 rot="16288800">
            <a:off x="2940840" y="9572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14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rot="16288800">
            <a:off x="1747080" y="8265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4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rot="16288800">
            <a:off x="1726560" y="56196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4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 rot="16288800">
            <a:off x="1431000" y="566892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4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 rot="16288800">
            <a:off x="1535760" y="17524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9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 rot="16288800">
            <a:off x="6071400" y="57366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4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 rot="16288800">
            <a:off x="5795280" y="521964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4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 rot="16288800">
            <a:off x="2469240" y="8064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6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 rot="16288800">
            <a:off x="2240640" y="183924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7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 rot="16288800">
            <a:off x="2718720" y="54651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5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 rot="16288800">
            <a:off x="2471040" y="51508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3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rot="16288800">
            <a:off x="7119000" y="54561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5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 rot="16288800">
            <a:off x="6871320" y="514188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=3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 rot="21594600">
            <a:off x="2286360" y="6324480"/>
            <a:ext cx="8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Stra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 rot="21594600">
            <a:off x="6782040" y="6400800"/>
            <a:ext cx="8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Stra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 rot="21594600">
            <a:off x="2133720" y="3429000"/>
            <a:ext cx="89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T Stra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5717880" y="1371600"/>
            <a:ext cx="141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eatment Timing: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1371600" y="5972040"/>
            <a:ext cx="2895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5638680" y="6029280"/>
            <a:ext cx="3124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5638680" y="3809520"/>
            <a:ext cx="0" cy="2210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29T16:22:31Z</dcterms:created>
  <dc:creator>patricia</dc:creator>
  <dc:description/>
  <dc:language>en-US</dc:language>
  <cp:lastModifiedBy>patricia</cp:lastModifiedBy>
  <dcterms:modified xsi:type="dcterms:W3CDTF">2007-01-30T12:44:27Z</dcterms:modified>
  <cp:revision>9</cp:revision>
  <dc:subject/>
  <dc:title>PowerPoint Presentation</dc:title>
</cp:coreProperties>
</file>